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D1E0BE7-D70C-464D-A354-1017AAEE743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5AD0CD4-482D-4853-BEAC-B9B2A9A8682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4D3FF96-B0AE-4BF2-B154-3342A2F6B84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4E11C0F-484E-454E-B691-BCA020AA3AC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rtl="1">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1148061-6D9F-438F-836C-32A517E017F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8CABF91-2F96-4D98-B12E-192316299C1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A0120A-5651-44FA-BE83-7C1A1A272DA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C86B677-D79B-461C-9401-580F10484F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rtl="1">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1F2DC8-EB32-4395-9188-4FB4C4DA43E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A343C37-42DF-4D7D-BC84-8FEE9CBC251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59BCE4-8C7D-4D26-B368-A9256BD68C0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9147627-04FC-4C7A-A167-42658CAB9A1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552720" y="6244920"/>
            <a:ext cx="2133720" cy="476280"/>
          </a:xfrm>
          <a:prstGeom prst="rect">
            <a:avLst/>
          </a:prstGeom>
          <a:noFill/>
          <a:ln w="0">
            <a:noFill/>
          </a:ln>
        </p:spPr>
        <p:txBody>
          <a:bodyPr lIns="90000" rIns="90000" tIns="46800" bIns="46800" anchor="t">
            <a:noAutofit/>
          </a:bodyPr>
          <a:lstStyle>
            <a:lvl1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56840" y="6244920"/>
            <a:ext cx="2133720" cy="476280"/>
          </a:xfrm>
          <a:prstGeom prst="rect">
            <a:avLst/>
          </a:prstGeom>
          <a:noFill/>
          <a:ln w="0">
            <a:noFill/>
          </a:ln>
        </p:spPr>
        <p:txBody>
          <a:bodyPr lIns="90000" rIns="90000" tIns="46800" bIns="46800" anchor="t">
            <a:noAutofit/>
          </a:bodyPr>
          <a:lstStyle>
            <a:lvl1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54ACE4F-F0B9-4BF4-9EF9-D20C712B47B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371600" y="1066680"/>
            <a:ext cx="3809880" cy="366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42" name="" descr=""/>
          <p:cNvPicPr/>
          <p:nvPr/>
        </p:nvPicPr>
        <p:blipFill>
          <a:blip r:embed="rId1"/>
          <a:stretch/>
        </p:blipFill>
        <p:spPr>
          <a:xfrm>
            <a:off x="1623960" y="3124080"/>
            <a:ext cx="7443720" cy="2806920"/>
          </a:xfrm>
          <a:prstGeom prst="rect">
            <a:avLst/>
          </a:prstGeom>
          <a:ln w="0">
            <a:noFill/>
          </a:ln>
        </p:spPr>
      </p:pic>
      <p:sp>
        <p:nvSpPr>
          <p:cNvPr id="43" name=""/>
          <p:cNvSpPr/>
          <p:nvPr/>
        </p:nvSpPr>
        <p:spPr>
          <a:xfrm>
            <a:off x="685800" y="609480"/>
            <a:ext cx="7620120" cy="2031840"/>
          </a:xfrm>
          <a:prstGeom prst="rect">
            <a:avLst/>
          </a:prstGeom>
          <a:noFill/>
          <a:ln w="0">
            <a:noFill/>
          </a:ln>
        </p:spPr>
        <p:style>
          <a:lnRef idx="0"/>
          <a:fillRef idx="0"/>
          <a:effectRef idx="0"/>
          <a:fontRef idx="minor"/>
        </p:style>
        <p:txBody>
          <a:bodyPr lIns="90000" rIns="90000" tIns="46800" bIns="46800" anchor="t">
            <a:spAutoFit/>
          </a:bodyPr>
          <a:p>
            <a:pPr>
              <a:lnSpc>
                <a:spcPct val="1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Supplementary Network Randomisation Rules Figure</a:t>
            </a:r>
            <a:endParaRPr b="0" lang="en-US" sz="1400" spc="-1" strike="noStrike">
              <a:solidFill>
                <a:srgbClr val="000000"/>
              </a:solidFill>
              <a:latin typeface="Arial"/>
            </a:endParaRPr>
          </a:p>
          <a:p>
            <a:pPr>
              <a:lnSpc>
                <a:spcPct val="1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1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The network randomisation rules.  Each node (immune cell- red or body cell- blue) is paired at random with other nodes, but without changing the legitimate numbers and input and output directions of the edges of each node defined by the real system.  Edges are colour coded as follows: red- between immune cells, blue- between body cells, green- between immune source cell to body target cell and pink- between body source cell to immune target cell.</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5-02-05T12:55:11Z</dcterms:created>
  <dc:creator>Weizmann Institute of Science</dc:creator>
  <dc:description/>
  <dc:language>en-US</dc:language>
  <cp:lastModifiedBy>Weizmann Institute of Science</cp:lastModifiedBy>
  <dcterms:modified xsi:type="dcterms:W3CDTF">2006-07-27T16:01:04Z</dcterms:modified>
  <cp:revision>9</cp:revision>
  <dc:subject/>
  <dc:title>Slide 1</dc:title>
</cp:coreProperties>
</file>